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6"/>
  </p:notesMasterIdLst>
  <p:sldIdLst>
    <p:sldId id="2147374740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48" d="100"/>
          <a:sy n="48" d="100"/>
        </p:scale>
        <p:origin x="2096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orgard,Dr.,Bobby (DR CI+IM) BIP-US-R" userId="8fb42a27-e12b-430d-ab3b-20c232fde4c7" providerId="ADAL" clId="{FE824688-9226-4F28-9D59-05352CD98B29}"/>
    <pc:docChg chg="delSld">
      <pc:chgData name="Norgard,Dr.,Bobby (DR CI+IM) BIP-US-R" userId="8fb42a27-e12b-430d-ab3b-20c232fde4c7" providerId="ADAL" clId="{FE824688-9226-4F28-9D59-05352CD98B29}" dt="2024-05-02T15:23:28.452" v="7" actId="47"/>
      <pc:docMkLst>
        <pc:docMk/>
      </pc:docMkLst>
      <pc:sldChg chg="del">
        <pc:chgData name="Norgard,Dr.,Bobby (DR CI+IM) BIP-US-R" userId="8fb42a27-e12b-430d-ab3b-20c232fde4c7" providerId="ADAL" clId="{FE824688-9226-4F28-9D59-05352CD98B29}" dt="2024-05-02T15:23:27.731" v="5" actId="47"/>
        <pc:sldMkLst>
          <pc:docMk/>
          <pc:sldMk cId="408838272" sldId="2147374672"/>
        </pc:sldMkLst>
      </pc:sldChg>
      <pc:sldChg chg="del">
        <pc:chgData name="Norgard,Dr.,Bobby (DR CI+IM) BIP-US-R" userId="8fb42a27-e12b-430d-ab3b-20c232fde4c7" providerId="ADAL" clId="{FE824688-9226-4F28-9D59-05352CD98B29}" dt="2024-05-02T15:23:26.433" v="2" actId="47"/>
        <pc:sldMkLst>
          <pc:docMk/>
          <pc:sldMk cId="3710560620" sldId="2147374714"/>
        </pc:sldMkLst>
      </pc:sldChg>
      <pc:sldChg chg="del">
        <pc:chgData name="Norgard,Dr.,Bobby (DR CI+IM) BIP-US-R" userId="8fb42a27-e12b-430d-ab3b-20c232fde4c7" providerId="ADAL" clId="{FE824688-9226-4F28-9D59-05352CD98B29}" dt="2024-05-02T15:23:24.292" v="0" actId="47"/>
        <pc:sldMkLst>
          <pc:docMk/>
          <pc:sldMk cId="457411378" sldId="2147374715"/>
        </pc:sldMkLst>
      </pc:sldChg>
      <pc:sldChg chg="del">
        <pc:chgData name="Norgard,Dr.,Bobby (DR CI+IM) BIP-US-R" userId="8fb42a27-e12b-430d-ab3b-20c232fde4c7" providerId="ADAL" clId="{FE824688-9226-4F28-9D59-05352CD98B29}" dt="2024-05-02T15:23:26.883" v="3" actId="47"/>
        <pc:sldMkLst>
          <pc:docMk/>
          <pc:sldMk cId="1104710727" sldId="2147374723"/>
        </pc:sldMkLst>
      </pc:sldChg>
      <pc:sldChg chg="del">
        <pc:chgData name="Norgard,Dr.,Bobby (DR CI+IM) BIP-US-R" userId="8fb42a27-e12b-430d-ab3b-20c232fde4c7" providerId="ADAL" clId="{FE824688-9226-4F28-9D59-05352CD98B29}" dt="2024-05-02T15:23:24.954" v="1" actId="47"/>
        <pc:sldMkLst>
          <pc:docMk/>
          <pc:sldMk cId="2434237610" sldId="2147374739"/>
        </pc:sldMkLst>
      </pc:sldChg>
      <pc:sldChg chg="del">
        <pc:chgData name="Norgard,Dr.,Bobby (DR CI+IM) BIP-US-R" userId="8fb42a27-e12b-430d-ab3b-20c232fde4c7" providerId="ADAL" clId="{FE824688-9226-4F28-9D59-05352CD98B29}" dt="2024-05-02T15:23:27.337" v="4" actId="47"/>
        <pc:sldMkLst>
          <pc:docMk/>
          <pc:sldMk cId="1380050138" sldId="2147374741"/>
        </pc:sldMkLst>
      </pc:sldChg>
      <pc:sldChg chg="del">
        <pc:chgData name="Norgard,Dr.,Bobby (DR CI+IM) BIP-US-R" userId="8fb42a27-e12b-430d-ab3b-20c232fde4c7" providerId="ADAL" clId="{FE824688-9226-4F28-9D59-05352CD98B29}" dt="2024-05-02T15:23:28.452" v="7" actId="47"/>
        <pc:sldMkLst>
          <pc:docMk/>
          <pc:sldMk cId="2257143359" sldId="2147374742"/>
        </pc:sldMkLst>
      </pc:sldChg>
      <pc:sldChg chg="del">
        <pc:chgData name="Norgard,Dr.,Bobby (DR CI+IM) BIP-US-R" userId="8fb42a27-e12b-430d-ab3b-20c232fde4c7" providerId="ADAL" clId="{FE824688-9226-4F28-9D59-05352CD98B29}" dt="2024-05-02T15:23:28.139" v="6" actId="47"/>
        <pc:sldMkLst>
          <pc:docMk/>
          <pc:sldMk cId="1015601671" sldId="2147374743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B95551-484D-43A4-B9A5-B2D7F224AFCA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21CA44-8096-4E9E-B465-288E5699C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315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8194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3345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49214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Stand-al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14874-C1A9-453A-A6DE-ABB2EB5A8140}" type="datetime1">
              <a:rPr lang="en-GB" noProof="0" smtClean="0"/>
              <a:t>02/05/2024</a:t>
            </a:fld>
            <a:endParaRPr lang="en-GB" noProof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noProof="0"/>
              <a:t>Periostin In Vivo Planning_KPCY Monotherapy/PK Study</a:t>
            </a:r>
            <a:endParaRPr lang="en-GB" noProof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B55C4-4F5A-416B-997D-6CE47EB0A945}" type="slidenum">
              <a:rPr lang="en-GB" noProof="0" smtClean="0"/>
              <a:t>‹#›</a:t>
            </a:fld>
            <a:endParaRPr lang="en-GB" noProof="0"/>
          </a:p>
        </p:txBody>
      </p:sp>
      <p:cxnSp>
        <p:nvCxnSpPr>
          <p:cNvPr id="7" name="Gerade Verbindung 6"/>
          <p:cNvCxnSpPr/>
          <p:nvPr userDrawn="1"/>
        </p:nvCxnSpPr>
        <p:spPr>
          <a:xfrm>
            <a:off x="0" y="1295271"/>
            <a:ext cx="6858000" cy="0"/>
          </a:xfrm>
          <a:prstGeom prst="line">
            <a:avLst/>
          </a:prstGeom>
          <a:ln w="12700">
            <a:solidFill>
              <a:srgbClr val="003366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8" name="Grafik 6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3332" y="8647345"/>
            <a:ext cx="472703" cy="3386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177595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506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76422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43484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6182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6711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5181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70597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29701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400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  <p:sldLayoutId id="2147483684" r:id="rId12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1" name="Object 120">
            <a:extLst>
              <a:ext uri="{FF2B5EF4-FFF2-40B4-BE49-F238E27FC236}">
                <a16:creationId xmlns:a16="http://schemas.microsoft.com/office/drawing/2014/main" id="{41A3759C-20E4-B22C-6FC0-BC5D943D10E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06713" y="2950715"/>
          <a:ext cx="5391150" cy="1731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9267732" imgH="2983876" progId="Prism9.Document">
                  <p:embed/>
                </p:oleObj>
              </mc:Choice>
              <mc:Fallback>
                <p:oleObj name="Prism 9" r:id="rId2" imgW="9267732" imgH="2983876" progId="Prism9.Document">
                  <p:embed/>
                  <p:pic>
                    <p:nvPicPr>
                      <p:cNvPr id="121" name="Object 120">
                        <a:extLst>
                          <a:ext uri="{FF2B5EF4-FFF2-40B4-BE49-F238E27FC236}">
                            <a16:creationId xmlns:a16="http://schemas.microsoft.com/office/drawing/2014/main" id="{41A3759C-20E4-B22C-6FC0-BC5D943D10E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06713" y="2950715"/>
                        <a:ext cx="5391150" cy="17319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4" name="TextBox 113">
            <a:extLst>
              <a:ext uri="{FF2B5EF4-FFF2-40B4-BE49-F238E27FC236}">
                <a16:creationId xmlns:a16="http://schemas.microsoft.com/office/drawing/2014/main" id="{62E04CA4-A8BA-0F28-BEAB-8263435962DB}"/>
              </a:ext>
            </a:extLst>
          </p:cNvPr>
          <p:cNvSpPr txBox="1"/>
          <p:nvPr/>
        </p:nvSpPr>
        <p:spPr>
          <a:xfrm>
            <a:off x="154459" y="1371315"/>
            <a:ext cx="16228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/>
              <a:t>A.</a:t>
            </a:r>
          </a:p>
        </p:txBody>
      </p:sp>
      <p:pic>
        <p:nvPicPr>
          <p:cNvPr id="2" name="Picture 1" descr="A computer screen shot of a mouse&#10;&#10;Description automatically generated">
            <a:extLst>
              <a:ext uri="{FF2B5EF4-FFF2-40B4-BE49-F238E27FC236}">
                <a16:creationId xmlns:a16="http://schemas.microsoft.com/office/drawing/2014/main" id="{554DF1D0-2C32-3CD6-DFD8-0D5C4B17D18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714" b="28656"/>
          <a:stretch/>
        </p:blipFill>
        <p:spPr>
          <a:xfrm>
            <a:off x="401127" y="1494658"/>
            <a:ext cx="3806493" cy="1295781"/>
          </a:xfrm>
          <a:prstGeom prst="rect">
            <a:avLst/>
          </a:prstGeom>
        </p:spPr>
      </p:pic>
      <p:sp>
        <p:nvSpPr>
          <p:cNvPr id="116" name="TextBox 115">
            <a:extLst>
              <a:ext uri="{FF2B5EF4-FFF2-40B4-BE49-F238E27FC236}">
                <a16:creationId xmlns:a16="http://schemas.microsoft.com/office/drawing/2014/main" id="{001C7C4C-720D-59B9-A35F-D7B9FCE7767B}"/>
              </a:ext>
            </a:extLst>
          </p:cNvPr>
          <p:cNvSpPr txBox="1"/>
          <p:nvPr/>
        </p:nvSpPr>
        <p:spPr>
          <a:xfrm>
            <a:off x="159652" y="2950715"/>
            <a:ext cx="151901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/>
              <a:t>B.</a:t>
            </a:r>
          </a:p>
        </p:txBody>
      </p:sp>
      <p:pic>
        <p:nvPicPr>
          <p:cNvPr id="119" name="Picture 118">
            <a:extLst>
              <a:ext uri="{FF2B5EF4-FFF2-40B4-BE49-F238E27FC236}">
                <a16:creationId xmlns:a16="http://schemas.microsoft.com/office/drawing/2014/main" id="{DBEB9F27-C8DB-8717-7EB7-4C88C60A449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2781" t="17037" b="57589"/>
          <a:stretch/>
        </p:blipFill>
        <p:spPr>
          <a:xfrm>
            <a:off x="5078711" y="2799409"/>
            <a:ext cx="1472576" cy="69221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A88CE35-82A8-8440-6472-A313DC4FF1AC}"/>
              </a:ext>
            </a:extLst>
          </p:cNvPr>
          <p:cNvSpPr txBox="1"/>
          <p:nvPr/>
        </p:nvSpPr>
        <p:spPr>
          <a:xfrm>
            <a:off x="691978" y="5313405"/>
            <a:ext cx="5005885" cy="12157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</a:t>
            </a: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xperiment design of adoptive transfer and treatment. </a:t>
            </a:r>
            <a:r>
              <a:rPr lang="en-US" sz="11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. 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ar graphs showing the composition of adoptively transferred (CD45.1+) T cells that are either CTV+ (undivided) or CTV+ (divided) as absolute counts in tumor, spleen, draining lymph nodes (</a:t>
            </a:r>
            <a:r>
              <a:rPr lang="en-US" sz="1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LN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and blood with Vehicle or SOS1i+MEKi treatment. </a:t>
            </a:r>
            <a:endParaRPr lang="en-US" sz="1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US" dirty="0"/>
          </a:p>
        </p:txBody>
      </p:sp>
      <p:sp>
        <p:nvSpPr>
          <p:cNvPr id="6" name="Title 2">
            <a:extLst>
              <a:ext uri="{FF2B5EF4-FFF2-40B4-BE49-F238E27FC236}">
                <a16:creationId xmlns:a16="http://schemas.microsoft.com/office/drawing/2014/main" id="{A55E7EFC-7D23-AF9E-5309-D11A084B4870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6657975" cy="3079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200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</p:spTree>
    <p:extLst>
      <p:ext uri="{BB962C8B-B14F-4D97-AF65-F5344CB8AC3E}">
        <p14:creationId xmlns:p14="http://schemas.microsoft.com/office/powerpoint/2010/main" val="5297289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9acdd090-06b3-455d-ab64-99cb7fe7470c">
      <Terms xmlns="http://schemas.microsoft.com/office/infopath/2007/PartnerControls"/>
    </lcf76f155ced4ddcb4097134ff3c332f>
    <TaxCatchAll xmlns="e47812bf-c8f0-415c-9dc6-756594725798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9451DDB2A9AB341B622F9036981046A" ma:contentTypeVersion="17" ma:contentTypeDescription="Create a new document." ma:contentTypeScope="" ma:versionID="44c2e872cbac6b246f5d634d493eb487">
  <xsd:schema xmlns:xsd="http://www.w3.org/2001/XMLSchema" xmlns:xs="http://www.w3.org/2001/XMLSchema" xmlns:p="http://schemas.microsoft.com/office/2006/metadata/properties" xmlns:ns2="9acdd090-06b3-455d-ab64-99cb7fe7470c" xmlns:ns3="926762ed-9515-4d6a-a527-d28b70bf3669" xmlns:ns4="e47812bf-c8f0-415c-9dc6-756594725798" targetNamespace="http://schemas.microsoft.com/office/2006/metadata/properties" ma:root="true" ma:fieldsID="eb05650a2fac9d65bfaa2aafe88c574a" ns2:_="" ns3:_="" ns4:_="">
    <xsd:import namespace="9acdd090-06b3-455d-ab64-99cb7fe7470c"/>
    <xsd:import namespace="926762ed-9515-4d6a-a527-d28b70bf3669"/>
    <xsd:import namespace="e47812bf-c8f0-415c-9dc6-756594725798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AutoKeyPoints" minOccurs="0"/>
                <xsd:element ref="ns2:MediaServiceKeyPoints" minOccurs="0"/>
                <xsd:element ref="ns2:lcf76f155ced4ddcb4097134ff3c332f" minOccurs="0"/>
                <xsd:element ref="ns4:TaxCatchAll" minOccurs="0"/>
                <xsd:element ref="ns2:MediaServiceDateTaken" minOccurs="0"/>
                <xsd:element ref="ns2:MediaLengthInSeconds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acdd090-06b3-455d-ab64-99cb7fe7470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lcf76f155ced4ddcb4097134ff3c332f" ma:index="19" nillable="true" ma:taxonomy="true" ma:internalName="lcf76f155ced4ddcb4097134ff3c332f" ma:taxonomyFieldName="MediaServiceImageTags" ma:displayName="Image Tags" ma:readOnly="false" ma:fieldId="{5cf76f15-5ced-4ddc-b409-7134ff3c332f}" ma:taxonomyMulti="true" ma:sspId="798f3110-b2b7-48bc-b5f0-a137367be0c9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21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22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2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26762ed-9515-4d6a-a527-d28b70bf3669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47812bf-c8f0-415c-9dc6-756594725798" elementFormDefault="qualified">
    <xsd:import namespace="http://schemas.microsoft.com/office/2006/documentManagement/types"/>
    <xsd:import namespace="http://schemas.microsoft.com/office/infopath/2007/PartnerControls"/>
    <xsd:element name="TaxCatchAll" ma:index="20" nillable="true" ma:displayName="Taxonomy Catch All Column" ma:hidden="true" ma:list="{178fb918-bae2-4388-ae3c-9857c311f631}" ma:internalName="TaxCatchAll" ma:showField="CatchAllData" ma:web="926762ed-9515-4d6a-a527-d28b70bf366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0ED1A073-550F-498F-B90D-40453BF36B9D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A8CBD9CD-A4AA-415E-872A-4904A09AF53E}">
  <ds:schemaRefs>
    <ds:schemaRef ds:uri="http://purl.org/dc/elements/1.1/"/>
    <ds:schemaRef ds:uri="http://schemas.microsoft.com/office/infopath/2007/PartnerControls"/>
    <ds:schemaRef ds:uri="http://purl.org/dc/terms/"/>
    <ds:schemaRef ds:uri="http://schemas.microsoft.com/office/2006/metadata/properties"/>
    <ds:schemaRef ds:uri="9acdd090-06b3-455d-ab64-99cb7fe7470c"/>
    <ds:schemaRef ds:uri="http://schemas.microsoft.com/office/2006/documentManagement/types"/>
    <ds:schemaRef ds:uri="http://schemas.openxmlformats.org/package/2006/metadata/core-properties"/>
    <ds:schemaRef ds:uri="e47812bf-c8f0-415c-9dc6-756594725798"/>
    <ds:schemaRef ds:uri="926762ed-9515-4d6a-a527-d28b70bf3669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8119F5F3-63F0-455D-B14B-B78AB0E631F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acdd090-06b3-455d-ab64-99cb7fe7470c"/>
    <ds:schemaRef ds:uri="926762ed-9515-4d6a-a527-d28b70bf3669"/>
    <ds:schemaRef ds:uri="e47812bf-c8f0-415c-9dc6-75659472579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Metadata/LabelInfo.xml><?xml version="1.0" encoding="utf-8"?>
<clbl:labelList xmlns:clbl="http://schemas.microsoft.com/office/2020/mipLabelMetadata">
  <clbl:label id="{e1f8af86-ee95-4718-bd0d-375b37366c83}" enabled="0" method="" siteId="{e1f8af86-ee95-4718-bd0d-375b37366c83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8</TotalTime>
  <Words>74</Words>
  <Application>Microsoft Office PowerPoint</Application>
  <PresentationFormat>Letter Paper (8.5x11 in)</PresentationFormat>
  <Paragraphs>4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9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'Brien,Dr.,Sarah (RES CI+IM) BIP-US-R</dc:creator>
  <cp:lastModifiedBy>Norgard,Dr.,Bobby (DR CI+IM) BIP-US-R</cp:lastModifiedBy>
  <cp:revision>6</cp:revision>
  <dcterms:created xsi:type="dcterms:W3CDTF">2024-01-18T14:22:02Z</dcterms:created>
  <dcterms:modified xsi:type="dcterms:W3CDTF">2024-05-02T15:23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9451DDB2A9AB341B622F9036981046A</vt:lpwstr>
  </property>
  <property fmtid="{D5CDD505-2E9C-101B-9397-08002B2CF9AE}" pid="3" name="MediaServiceImageTags">
    <vt:lpwstr/>
  </property>
</Properties>
</file>